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9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52" autoAdjust="0"/>
    <p:restoredTop sz="96247" autoAdjust="0"/>
  </p:normalViewPr>
  <p:slideViewPr>
    <p:cSldViewPr snapToGrid="0">
      <p:cViewPr varScale="1">
        <p:scale>
          <a:sx n="77" d="100"/>
          <a:sy n="77" d="100"/>
        </p:scale>
        <p:origin x="351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37FEF0-7CAB-432B-A1C8-95A08DA7ECAE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734DF-5F11-4274-A00D-0BA1A80B1E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7102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305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0479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76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11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990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593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10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463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0005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05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722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8176C-05BB-41EC-A966-3A5842D5082D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4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92D513B5-4BDE-4371-905C-3D816057EE8E}"/>
              </a:ext>
            </a:extLst>
          </p:cNvPr>
          <p:cNvSpPr txBox="1"/>
          <p:nvPr/>
        </p:nvSpPr>
        <p:spPr>
          <a:xfrm>
            <a:off x="507510" y="272598"/>
            <a:ext cx="2101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able S4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17CE5EE-711A-4ADA-A414-76643E2008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7510" y="549597"/>
            <a:ext cx="5356763" cy="81534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D9125C5-2DDE-4B83-86E1-414F5629ADA0}"/>
              </a:ext>
            </a:extLst>
          </p:cNvPr>
          <p:cNvSpPr txBox="1"/>
          <p:nvPr/>
        </p:nvSpPr>
        <p:spPr>
          <a:xfrm>
            <a:off x="258739" y="8894738"/>
            <a:ext cx="63405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able S4 shows the absolute values of albumin, creatinine and albumin creatinine ratio from 3 independent experiments carried out on diabetic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i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+ MMPI or vehicle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mice. </a:t>
            </a:r>
          </a:p>
        </p:txBody>
      </p:sp>
    </p:spTree>
    <p:extLst>
      <p:ext uri="{BB962C8B-B14F-4D97-AF65-F5344CB8AC3E}">
        <p14:creationId xmlns:p14="http://schemas.microsoft.com/office/powerpoint/2010/main" val="133182276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768</TotalTime>
  <Words>36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a Ramnath</dc:creator>
  <cp:lastModifiedBy>Raina Ramnath</cp:lastModifiedBy>
  <cp:revision>662</cp:revision>
  <cp:lastPrinted>2018-11-05T10:42:07Z</cp:lastPrinted>
  <dcterms:created xsi:type="dcterms:W3CDTF">2018-02-07T14:08:32Z</dcterms:created>
  <dcterms:modified xsi:type="dcterms:W3CDTF">2019-09-06T08:57:55Z</dcterms:modified>
</cp:coreProperties>
</file>